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6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5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44824" y="5940152"/>
            <a:ext cx="27753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Additional file </a:t>
            </a:r>
            <a:r>
              <a:rPr lang="en-AU" b="1" dirty="0" smtClean="0"/>
              <a:t>13: Table S4 </a:t>
            </a:r>
            <a:endParaRPr lang="en-AU" b="1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332656" y="2267744"/>
          <a:ext cx="6072340" cy="2809113"/>
        </p:xfrm>
        <a:graphic>
          <a:graphicData uri="http://schemas.openxmlformats.org/drawingml/2006/table">
            <a:tbl>
              <a:tblPr/>
              <a:tblGrid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</a:tblGrid>
              <a:tr h="251231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AU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ble </a:t>
                      </a:r>
                      <a:r>
                        <a:rPr lang="en-AU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4</a:t>
                      </a:r>
                      <a:r>
                        <a:rPr lang="en-A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emical composition of ROC stream after </a:t>
                      </a:r>
                      <a:r>
                        <a:rPr lang="en-A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eatment 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ith assembled biofil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2019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ay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4,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3,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,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i,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n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b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886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ay 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5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2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886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ay 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837">
                <a:tc>
                  <a:txBody>
                    <a:bodyPr/>
                    <a:lstStyle/>
                    <a:p>
                      <a:pPr algn="ctr" fontAlgn="ctr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1920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ld  decrea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5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6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33582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2</TotalTime>
  <Words>79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37:24Z</dcterms:modified>
</cp:coreProperties>
</file>